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95" d="100"/>
          <a:sy n="95" d="100"/>
        </p:scale>
        <p:origin x="2784" y="-9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mmond, John - REE-ARS" userId="c4636370-9abd-41f3-81dc-0529d80fa84a" providerId="ADAL" clId="{4F42E920-FA07-409F-B436-76C539000848}"/>
    <pc:docChg chg="modSld">
      <pc:chgData name="Hammond, John - REE-ARS" userId="c4636370-9abd-41f3-81dc-0529d80fa84a" providerId="ADAL" clId="{4F42E920-FA07-409F-B436-76C539000848}" dt="2025-03-09T19:20:46.611" v="7" actId="13926"/>
      <pc:docMkLst>
        <pc:docMk/>
      </pc:docMkLst>
      <pc:sldChg chg="modSp mod">
        <pc:chgData name="Hammond, John - REE-ARS" userId="c4636370-9abd-41f3-81dc-0529d80fa84a" providerId="ADAL" clId="{4F42E920-FA07-409F-B436-76C539000848}" dt="2025-03-09T19:20:46.611" v="7" actId="13926"/>
        <pc:sldMkLst>
          <pc:docMk/>
          <pc:sldMk cId="320524866" sldId="256"/>
        </pc:sldMkLst>
        <pc:spChg chg="mod">
          <ac:chgData name="Hammond, John - REE-ARS" userId="c4636370-9abd-41f3-81dc-0529d80fa84a" providerId="ADAL" clId="{4F42E920-FA07-409F-B436-76C539000848}" dt="2025-03-09T19:20:46.611" v="7" actId="13926"/>
          <ac:spMkLst>
            <pc:docMk/>
            <pc:sldMk cId="320524866" sldId="256"/>
            <ac:spMk id="4" creationId="{9DDA983C-2E0F-022B-2412-8960ED978F63}"/>
          </ac:spMkLst>
        </pc:spChg>
        <pc:spChg chg="mod">
          <ac:chgData name="Hammond, John - REE-ARS" userId="c4636370-9abd-41f3-81dc-0529d80fa84a" providerId="ADAL" clId="{4F42E920-FA07-409F-B436-76C539000848}" dt="2025-03-09T19:20:36.673" v="5" actId="13926"/>
          <ac:spMkLst>
            <pc:docMk/>
            <pc:sldMk cId="320524866" sldId="256"/>
            <ac:spMk id="8" creationId="{B7BA5DD0-92A4-5644-59EB-262B55C78A72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432A3-5794-4668-B28D-ABC33A4011C7}" type="datetimeFigureOut">
              <a:rPr lang="it-IT" smtClean="0"/>
              <a:t>19/03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4365A-6FF9-4DC1-B86A-C967CDB8B3B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4982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432A3-5794-4668-B28D-ABC33A4011C7}" type="datetimeFigureOut">
              <a:rPr lang="it-IT" smtClean="0"/>
              <a:t>19/03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4365A-6FF9-4DC1-B86A-C967CDB8B3B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888281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432A3-5794-4668-B28D-ABC33A4011C7}" type="datetimeFigureOut">
              <a:rPr lang="it-IT" smtClean="0"/>
              <a:t>19/03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4365A-6FF9-4DC1-B86A-C967CDB8B3B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657136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432A3-5794-4668-B28D-ABC33A4011C7}" type="datetimeFigureOut">
              <a:rPr lang="it-IT" smtClean="0"/>
              <a:t>19/03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4365A-6FF9-4DC1-B86A-C967CDB8B3B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298332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432A3-5794-4668-B28D-ABC33A4011C7}" type="datetimeFigureOut">
              <a:rPr lang="it-IT" smtClean="0"/>
              <a:t>19/03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4365A-6FF9-4DC1-B86A-C967CDB8B3B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081026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432A3-5794-4668-B28D-ABC33A4011C7}" type="datetimeFigureOut">
              <a:rPr lang="it-IT" smtClean="0"/>
              <a:t>19/03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4365A-6FF9-4DC1-B86A-C967CDB8B3B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2251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432A3-5794-4668-B28D-ABC33A4011C7}" type="datetimeFigureOut">
              <a:rPr lang="it-IT" smtClean="0"/>
              <a:t>19/03/2025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4365A-6FF9-4DC1-B86A-C967CDB8B3B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29717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432A3-5794-4668-B28D-ABC33A4011C7}" type="datetimeFigureOut">
              <a:rPr lang="it-IT" smtClean="0"/>
              <a:t>19/03/202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4365A-6FF9-4DC1-B86A-C967CDB8B3B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359630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432A3-5794-4668-B28D-ABC33A4011C7}" type="datetimeFigureOut">
              <a:rPr lang="it-IT" smtClean="0"/>
              <a:t>19/03/2025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4365A-6FF9-4DC1-B86A-C967CDB8B3B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53424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432A3-5794-4668-B28D-ABC33A4011C7}" type="datetimeFigureOut">
              <a:rPr lang="it-IT" smtClean="0"/>
              <a:t>19/03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4365A-6FF9-4DC1-B86A-C967CDB8B3B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636326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432A3-5794-4668-B28D-ABC33A4011C7}" type="datetimeFigureOut">
              <a:rPr lang="it-IT" smtClean="0"/>
              <a:t>19/03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4365A-6FF9-4DC1-B86A-C967CDB8B3B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23453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B4432A3-5794-4668-B28D-ABC33A4011C7}" type="datetimeFigureOut">
              <a:rPr lang="it-IT" smtClean="0"/>
              <a:t>19/03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324365A-6FF9-4DC1-B86A-C967CDB8B3B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975696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15">
            <a:extLst>
              <a:ext uri="{FF2B5EF4-FFF2-40B4-BE49-F238E27FC236}">
                <a16:creationId xmlns:a16="http://schemas.microsoft.com/office/drawing/2014/main" id="{9DDA983C-2E0F-022B-2412-8960ED978F63}"/>
              </a:ext>
            </a:extLst>
          </p:cNvPr>
          <p:cNvSpPr txBox="1"/>
          <p:nvPr/>
        </p:nvSpPr>
        <p:spPr>
          <a:xfrm>
            <a:off x="347662" y="7961780"/>
            <a:ext cx="6162675" cy="120032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en-US" sz="1200" b="1" dirty="0">
                <a:latin typeface="Times New Roman"/>
                <a:cs typeface="Times New Roman"/>
              </a:rPr>
              <a:t>Figure S3.</a:t>
            </a:r>
            <a:r>
              <a:rPr lang="en-US" sz="1200" dirty="0">
                <a:latin typeface="Times New Roman"/>
                <a:cs typeface="Times New Roman"/>
              </a:rPr>
              <a:t> Phylogenetic tree of nucleocapsid amino acid sequences of selected viral species listed in the </a:t>
            </a:r>
            <a:r>
              <a:rPr lang="en-US" sz="1200" i="1" dirty="0" err="1">
                <a:latin typeface="Times New Roman"/>
                <a:cs typeface="Times New Roman"/>
              </a:rPr>
              <a:t>Hareavirales</a:t>
            </a:r>
            <a:r>
              <a:rPr lang="en-US" sz="1200" dirty="0">
                <a:latin typeface="Times New Roman"/>
                <a:cs typeface="Times New Roman"/>
              </a:rPr>
              <a:t> order, the official species in </a:t>
            </a:r>
            <a:r>
              <a:rPr lang="en-US" sz="1200" i="1" dirty="0">
                <a:latin typeface="Times New Roman"/>
                <a:cs typeface="Times New Roman"/>
              </a:rPr>
              <a:t>Konkoviridae</a:t>
            </a:r>
            <a:r>
              <a:rPr lang="en-US" sz="1200" dirty="0">
                <a:latin typeface="Times New Roman"/>
                <a:cs typeface="Times New Roman"/>
              </a:rPr>
              <a:t> family and the newly discovered species possibly listing in </a:t>
            </a:r>
            <a:r>
              <a:rPr lang="en-US" sz="1200" i="1" dirty="0">
                <a:latin typeface="Times New Roman"/>
                <a:cs typeface="Times New Roman"/>
              </a:rPr>
              <a:t>Konkoviridae</a:t>
            </a:r>
            <a:r>
              <a:rPr lang="en-US" sz="1200" dirty="0">
                <a:latin typeface="Times New Roman"/>
                <a:cs typeface="Times New Roman"/>
              </a:rPr>
              <a:t> family (for which the RNA-2 full CDS has been obtained), computed by maximum likelihood (JTT matrix-based method). Consensus tree is constructed from 1,000 bootstrap trees. Numbers at nodes represent the percentage bootstrap values</a:t>
            </a:r>
            <a:endParaRPr lang="it-IT" sz="1200" dirty="0">
              <a:solidFill>
                <a:srgbClr val="FF0000"/>
              </a:solidFill>
              <a:latin typeface="Times New Roman"/>
              <a:cs typeface="Times New Roman"/>
            </a:endParaRPr>
          </a:p>
        </p:txBody>
      </p:sp>
      <p:pic>
        <p:nvPicPr>
          <p:cNvPr id="6" name="Immagine 5" descr="Immagine che contiene testo, Carattere, documento, ricevuta&#10;&#10;Il contenuto generato dall'IA potrebbe non essere corretto.">
            <a:extLst>
              <a:ext uri="{FF2B5EF4-FFF2-40B4-BE49-F238E27FC236}">
                <a16:creationId xmlns:a16="http://schemas.microsoft.com/office/drawing/2014/main" id="{CECD39DD-76EC-4658-87C3-F6194F22E34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6205" y="326571"/>
            <a:ext cx="3104699" cy="7419703"/>
          </a:xfrm>
          <a:prstGeom prst="rect">
            <a:avLst/>
          </a:prstGeom>
        </p:spPr>
      </p:pic>
      <p:cxnSp>
        <p:nvCxnSpPr>
          <p:cNvPr id="7" name="Connettore diritto 6">
            <a:extLst>
              <a:ext uri="{FF2B5EF4-FFF2-40B4-BE49-F238E27FC236}">
                <a16:creationId xmlns:a16="http://schemas.microsoft.com/office/drawing/2014/main" id="{6B9F8339-499B-CD62-A089-398700101BDC}"/>
              </a:ext>
            </a:extLst>
          </p:cNvPr>
          <p:cNvCxnSpPr>
            <a:cxnSpLocks/>
          </p:cNvCxnSpPr>
          <p:nvPr/>
        </p:nvCxnSpPr>
        <p:spPr>
          <a:xfrm>
            <a:off x="4210904" y="423172"/>
            <a:ext cx="0" cy="1687614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B7BA5DD0-92A4-5644-59EB-262B55C78A72}"/>
              </a:ext>
            </a:extLst>
          </p:cNvPr>
          <p:cNvSpPr txBox="1"/>
          <p:nvPr/>
        </p:nvSpPr>
        <p:spPr>
          <a:xfrm>
            <a:off x="4210904" y="897647"/>
            <a:ext cx="17318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i="1" dirty="0">
                <a:solidFill>
                  <a:srgbClr val="FF0000"/>
                </a:solidFill>
              </a:rPr>
              <a:t>Konkoviridae</a:t>
            </a:r>
          </a:p>
        </p:txBody>
      </p:sp>
    </p:spTree>
    <p:extLst>
      <p:ext uri="{BB962C8B-B14F-4D97-AF65-F5344CB8AC3E}">
        <p14:creationId xmlns:p14="http://schemas.microsoft.com/office/powerpoint/2010/main" val="32052486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i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D3896766B253BF4C954DE14C4319FB08" ma:contentTypeVersion="11" ma:contentTypeDescription="Creare un nuovo documento." ma:contentTypeScope="" ma:versionID="55f3245f08a521eb9542d035c68db22e">
  <xsd:schema xmlns:xsd="http://www.w3.org/2001/XMLSchema" xmlns:xs="http://www.w3.org/2001/XMLSchema" xmlns:p="http://schemas.microsoft.com/office/2006/metadata/properties" xmlns:ns2="78083c92-0af9-4662-99b5-5fe34061947b" xmlns:ns3="dc1a3a29-1734-4967-8cff-d351e6fc4f0c" targetNamespace="http://schemas.microsoft.com/office/2006/metadata/properties" ma:root="true" ma:fieldsID="b9c0ba933e2b573af2568ceb043f1f1b" ns2:_="" ns3:_="">
    <xsd:import namespace="78083c92-0af9-4662-99b5-5fe34061947b"/>
    <xsd:import namespace="dc1a3a29-1734-4967-8cff-d351e6fc4f0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083c92-0af9-4662-99b5-5fe34061947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3" nillable="true" ma:taxonomy="true" ma:internalName="lcf76f155ced4ddcb4097134ff3c332f" ma:taxonomyFieldName="MediaServiceImageTags" ma:displayName="Tag immagine" ma:readOnly="false" ma:fieldId="{5cf76f15-5ced-4ddc-b409-7134ff3c332f}" ma:taxonomyMulti="true" ma:sspId="e5505f8f-da62-40e5-a116-f08e7003152c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5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c1a3a29-1734-4967-8cff-d351e6fc4f0c" elementFormDefault="qualified">
    <xsd:import namespace="http://schemas.microsoft.com/office/2006/documentManagement/types"/>
    <xsd:import namespace="http://schemas.microsoft.com/office/infopath/2007/PartnerControls"/>
    <xsd:element name="TaxCatchAll" ma:index="14" nillable="true" ma:displayName="Taxonomy Catch All Column" ma:hidden="true" ma:list="{e8a6735f-476e-414a-bdf7-a56c8e7d8966}" ma:internalName="TaxCatchAll" ma:showField="CatchAllData" ma:web="dc1a3a29-1734-4967-8cff-d351e6fc4f0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i contenuto"/>
        <xsd:element ref="dc:title" minOccurs="0" maxOccurs="1" ma:index="4" ma:displayName="Tito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dc1a3a29-1734-4967-8cff-d351e6fc4f0c" xsi:nil="true"/>
    <lcf76f155ced4ddcb4097134ff3c332f xmlns="78083c92-0af9-4662-99b5-5fe34061947b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C6513A7C-6268-41DF-94FB-26ECDB1DA86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8083c92-0af9-4662-99b5-5fe34061947b"/>
    <ds:schemaRef ds:uri="dc1a3a29-1734-4967-8cff-d351e6fc4f0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3F74043D-19BE-47F3-B627-28A4E57B4857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B082825-276E-4696-A4AE-73A50D5EB85A}">
  <ds:schemaRefs>
    <ds:schemaRef ds:uri="http://schemas.microsoft.com/office/2006/metadata/properties"/>
    <ds:schemaRef ds:uri="http://schemas.microsoft.com/office/infopath/2007/PartnerControls"/>
    <ds:schemaRef ds:uri="dc1a3a29-1734-4967-8cff-d351e6fc4f0c"/>
    <ds:schemaRef ds:uri="78083c92-0af9-4662-99b5-5fe34061947b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90</TotalTime>
  <Words>74</Words>
  <Application>Microsoft Office PowerPoint</Application>
  <PresentationFormat>A4 (21x29,7 cm)</PresentationFormat>
  <Paragraphs>2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AURA MIOZZI</dc:creator>
  <cp:lastModifiedBy>LAURA MIOZZI</cp:lastModifiedBy>
  <cp:revision>5</cp:revision>
  <dcterms:created xsi:type="dcterms:W3CDTF">2025-02-21T15:23:02Z</dcterms:created>
  <dcterms:modified xsi:type="dcterms:W3CDTF">2025-03-19T12:44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3896766B253BF4C954DE14C4319FB08</vt:lpwstr>
  </property>
</Properties>
</file>